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19" r:id="rId2"/>
  </p:sldIdLst>
  <p:sldSz cx="6264275" cy="84232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53" userDrawn="1">
          <p15:clr>
            <a:srgbClr val="A4A3A4"/>
          </p15:clr>
        </p15:guide>
        <p15:guide id="2" pos="197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99877"/>
    <a:srgbClr val="EEBC96"/>
    <a:srgbClr val="F4D4D4"/>
    <a:srgbClr val="F3D7D1"/>
    <a:srgbClr val="6087CE"/>
    <a:srgbClr val="4674C6"/>
    <a:srgbClr val="83ABD7"/>
    <a:srgbClr val="26457C"/>
    <a:srgbClr val="4472C4"/>
    <a:srgbClr val="9FB7E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651" autoAdjust="0"/>
    <p:restoredTop sz="94198" autoAdjust="0"/>
  </p:normalViewPr>
  <p:slideViewPr>
    <p:cSldViewPr>
      <p:cViewPr>
        <p:scale>
          <a:sx n="125" d="100"/>
          <a:sy n="125" d="100"/>
        </p:scale>
        <p:origin x="2478" y="-240"/>
      </p:cViewPr>
      <p:guideLst>
        <p:guide orient="horz" pos="2653"/>
        <p:guide pos="197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B5FF59-7695-48F5-AB78-39D11FDC9794}" type="datetimeFigureOut">
              <a:rPr lang="ko-KR" altLang="en-US" smtClean="0"/>
              <a:t>2025-05-1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81238" y="1143000"/>
            <a:ext cx="22955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6247F1-F2E7-41F9-89F3-984DCCE2D22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8756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1378532"/>
            <a:ext cx="5324634" cy="2932548"/>
          </a:xfrm>
        </p:spPr>
        <p:txBody>
          <a:bodyPr anchor="b"/>
          <a:lstStyle>
            <a:lvl1pPr algn="ctr">
              <a:defRPr sz="4111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3035" y="4424170"/>
            <a:ext cx="4698206" cy="2033674"/>
          </a:xfrm>
        </p:spPr>
        <p:txBody>
          <a:bodyPr/>
          <a:lstStyle>
            <a:lvl1pPr marL="0" indent="0" algn="ctr">
              <a:buNone/>
              <a:defRPr sz="1644"/>
            </a:lvl1pPr>
            <a:lvl2pPr marL="313228" indent="0" algn="ctr">
              <a:buNone/>
              <a:defRPr sz="1370"/>
            </a:lvl2pPr>
            <a:lvl3pPr marL="626455" indent="0" algn="ctr">
              <a:buNone/>
              <a:defRPr sz="1233"/>
            </a:lvl3pPr>
            <a:lvl4pPr marL="939683" indent="0" algn="ctr">
              <a:buNone/>
              <a:defRPr sz="1096"/>
            </a:lvl4pPr>
            <a:lvl5pPr marL="1252911" indent="0" algn="ctr">
              <a:buNone/>
              <a:defRPr sz="1096"/>
            </a:lvl5pPr>
            <a:lvl6pPr marL="1566139" indent="0" algn="ctr">
              <a:buNone/>
              <a:defRPr sz="1096"/>
            </a:lvl6pPr>
            <a:lvl7pPr marL="1879366" indent="0" algn="ctr">
              <a:buNone/>
              <a:defRPr sz="1096"/>
            </a:lvl7pPr>
            <a:lvl8pPr marL="2192594" indent="0" algn="ctr">
              <a:buNone/>
              <a:defRPr sz="1096"/>
            </a:lvl8pPr>
            <a:lvl9pPr marL="2505822" indent="0" algn="ctr">
              <a:buNone/>
              <a:defRPr sz="1096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5/1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266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5/1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966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82872" y="448462"/>
            <a:ext cx="1350734" cy="7138336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669" y="448462"/>
            <a:ext cx="3973899" cy="7138336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5/1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1882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5/1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1608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7407" y="2099972"/>
            <a:ext cx="5402937" cy="3503848"/>
          </a:xfrm>
        </p:spPr>
        <p:txBody>
          <a:bodyPr anchor="b"/>
          <a:lstStyle>
            <a:lvl1pPr>
              <a:defRPr sz="4111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407" y="5636967"/>
            <a:ext cx="5402937" cy="1842591"/>
          </a:xfrm>
        </p:spPr>
        <p:txBody>
          <a:bodyPr/>
          <a:lstStyle>
            <a:lvl1pPr marL="0" indent="0">
              <a:buNone/>
              <a:defRPr sz="1644">
                <a:solidFill>
                  <a:schemeClr val="tx1"/>
                </a:solidFill>
              </a:defRPr>
            </a:lvl1pPr>
            <a:lvl2pPr marL="313228" indent="0">
              <a:buNone/>
              <a:defRPr sz="1370">
                <a:solidFill>
                  <a:schemeClr val="tx1">
                    <a:tint val="75000"/>
                  </a:schemeClr>
                </a:solidFill>
              </a:defRPr>
            </a:lvl2pPr>
            <a:lvl3pPr marL="626455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3pPr>
            <a:lvl4pPr marL="939683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4pPr>
            <a:lvl5pPr marL="1252911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5pPr>
            <a:lvl6pPr marL="1566139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6pPr>
            <a:lvl7pPr marL="1879366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7pPr>
            <a:lvl8pPr marL="2192594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8pPr>
            <a:lvl9pPr marL="2505822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5/1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6505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669" y="2242307"/>
            <a:ext cx="2662317" cy="5344491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1289" y="2242307"/>
            <a:ext cx="2662317" cy="5344491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5/1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020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448463"/>
            <a:ext cx="5402937" cy="1628110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1485" y="2064873"/>
            <a:ext cx="2650082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1485" y="3076835"/>
            <a:ext cx="2650082" cy="4525561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1289" y="2064873"/>
            <a:ext cx="2663133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1289" y="3076835"/>
            <a:ext cx="2663133" cy="4525561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5/18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2597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5/18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612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5/18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65814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63133" y="1212797"/>
            <a:ext cx="3171289" cy="5985985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5/1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533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63133" y="1212797"/>
            <a:ext cx="3171289" cy="5985985"/>
          </a:xfrm>
        </p:spPr>
        <p:txBody>
          <a:bodyPr anchor="t"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5/1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401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669" y="448463"/>
            <a:ext cx="5402937" cy="16281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669" y="2242307"/>
            <a:ext cx="5402937" cy="53444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2ABF44-6F9F-4425-AB37-2FBDA0F51D67}" type="datetimeFigureOut">
              <a:rPr lang="en-US" smtClean="0"/>
              <a:pPr/>
              <a:t>5/1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22152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26455" rtl="0" eaLnBrk="1" latinLnBrk="1" hangingPunct="1">
        <a:lnSpc>
          <a:spcPct val="90000"/>
        </a:lnSpc>
        <a:spcBef>
          <a:spcPct val="0"/>
        </a:spcBef>
        <a:buNone/>
        <a:defRPr sz="30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4" indent="-156614" algn="l" defTabSz="626455" rtl="0" eaLnBrk="1" latinLnBrk="1" hangingPunct="1">
        <a:lnSpc>
          <a:spcPct val="90000"/>
        </a:lnSpc>
        <a:spcBef>
          <a:spcPts val="685"/>
        </a:spcBef>
        <a:buFont typeface="Arial" panose="020B0604020202020204" pitchFamily="34" charset="0"/>
        <a:buChar char="•"/>
        <a:defRPr sz="1918" kern="1200">
          <a:solidFill>
            <a:schemeClr val="tx1"/>
          </a:solidFill>
          <a:latin typeface="+mn-lt"/>
          <a:ea typeface="+mn-ea"/>
          <a:cs typeface="+mn-cs"/>
        </a:defRPr>
      </a:lvl1pPr>
      <a:lvl2pPr marL="469842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783069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370" kern="1200">
          <a:solidFill>
            <a:schemeClr val="tx1"/>
          </a:solidFill>
          <a:latin typeface="+mn-lt"/>
          <a:ea typeface="+mn-ea"/>
          <a:cs typeface="+mn-cs"/>
        </a:defRPr>
      </a:lvl3pPr>
      <a:lvl4pPr marL="1096297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409525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722752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2035980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349208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662436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직사각형 50">
            <a:extLst>
              <a:ext uri="{FF2B5EF4-FFF2-40B4-BE49-F238E27FC236}">
                <a16:creationId xmlns:a16="http://schemas.microsoft.com/office/drawing/2014/main" id="{C7F371A2-6707-456C-AFA8-E81FAC2C00C5}"/>
              </a:ext>
            </a:extLst>
          </p:cNvPr>
          <p:cNvSpPr/>
          <p:nvPr/>
        </p:nvSpPr>
        <p:spPr>
          <a:xfrm>
            <a:off x="48493" y="2627461"/>
            <a:ext cx="6156473" cy="400110"/>
          </a:xfrm>
          <a:prstGeom prst="rect">
            <a:avLst/>
          </a:prstGeom>
        </p:spPr>
        <p:txBody>
          <a:bodyPr wrap="square" lIns="0" rIns="0">
            <a:spAutoFit/>
          </a:bodyPr>
          <a:lstStyle/>
          <a:p>
            <a:r>
              <a:rPr lang="en-US" altLang="ko-KR" sz="1000" b="1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Supplementary Figure 1.</a:t>
            </a:r>
            <a:r>
              <a:rPr lang="en-US" altLang="ko-KR" sz="1000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</a:t>
            </a:r>
            <a:r>
              <a:rPr lang="en-US" altLang="ko-KR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 8-bp insertion in </a:t>
            </a:r>
            <a:r>
              <a:rPr lang="en-US" altLang="ko-KR" sz="10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B10</a:t>
            </a:r>
            <a:r>
              <a:rPr lang="en-US" altLang="ko-KR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n chromosome 1B identified by amplicon sequencing. The </a:t>
            </a:r>
            <a:r>
              <a:rPr lang="en-US" altLang="ko-KR" sz="10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neious</a:t>
            </a:r>
            <a:r>
              <a:rPr lang="en-US" altLang="ko-KR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creenshot shows part of exon 3 of </a:t>
            </a:r>
            <a:r>
              <a:rPr lang="en-US" altLang="ko-KR" sz="10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B10-1B</a:t>
            </a:r>
            <a:r>
              <a:rPr lang="en-US" altLang="ko-KR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including an 8-bp insertion in the reverse orientation. 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6" name="그룹 15">
            <a:extLst>
              <a:ext uri="{FF2B5EF4-FFF2-40B4-BE49-F238E27FC236}">
                <a16:creationId xmlns:a16="http://schemas.microsoft.com/office/drawing/2014/main" id="{4896947D-B1A4-4276-9129-8FAE2D9DEB30}"/>
              </a:ext>
            </a:extLst>
          </p:cNvPr>
          <p:cNvGrpSpPr/>
          <p:nvPr/>
        </p:nvGrpSpPr>
        <p:grpSpPr>
          <a:xfrm>
            <a:off x="740785" y="1355379"/>
            <a:ext cx="4803620" cy="1236078"/>
            <a:chOff x="690465" y="2997621"/>
            <a:chExt cx="4803620" cy="1236078"/>
          </a:xfrm>
        </p:grpSpPr>
        <p:pic>
          <p:nvPicPr>
            <p:cNvPr id="17" name="그림 16">
              <a:extLst>
                <a:ext uri="{FF2B5EF4-FFF2-40B4-BE49-F238E27FC236}">
                  <a16:creationId xmlns:a16="http://schemas.microsoft.com/office/drawing/2014/main" id="{FA1037DB-A50B-4923-96CC-AAB0CA66E41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267" b="50318"/>
            <a:stretch/>
          </p:blipFill>
          <p:spPr>
            <a:xfrm>
              <a:off x="690465" y="3154377"/>
              <a:ext cx="4803620" cy="1079322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F5ECF21-8CDC-46C4-B1AF-3EA588AA07E1}"/>
                </a:ext>
              </a:extLst>
            </p:cNvPr>
            <p:cNvSpPr txBox="1"/>
            <p:nvPr/>
          </p:nvSpPr>
          <p:spPr>
            <a:xfrm>
              <a:off x="2707359" y="2997621"/>
              <a:ext cx="1512858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8-bp insertion in </a:t>
              </a:r>
              <a:r>
                <a:rPr lang="en-US" altLang="ko-K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YB10</a:t>
              </a: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ko-K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1B</a:t>
              </a:r>
              <a:endParaRPr lang="ko-KR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674839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826</TotalTime>
  <Words>41</Words>
  <Application>Microsoft Office PowerPoint</Application>
  <PresentationFormat>사용자 지정</PresentationFormat>
  <Paragraphs>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맑은 고딕</vt:lpstr>
      <vt:lpstr>바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e Yoon Kim</dc:creator>
  <cp:lastModifiedBy>이만보</cp:lastModifiedBy>
  <cp:revision>281</cp:revision>
  <dcterms:created xsi:type="dcterms:W3CDTF">2012-09-21T02:05:55Z</dcterms:created>
  <dcterms:modified xsi:type="dcterms:W3CDTF">2025-05-18T07:12:18Z</dcterms:modified>
</cp:coreProperties>
</file>